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14"/>
  </p:normalViewPr>
  <p:slideViewPr>
    <p:cSldViewPr snapToGrid="0" snapToObjects="1">
      <p:cViewPr varScale="1">
        <p:scale>
          <a:sx n="90" d="100"/>
          <a:sy n="90" d="100"/>
        </p:scale>
        <p:origin x="23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heresa2/Desktop/Promotion/Quantitativ/Fertige%20Tabellen:Grafiken/%22Nebenthemen%22/Maternity%20clinic%20&amp;%20breastfeeding%20counselling%20(aufgeteilt%20nach%20Stillen%20bei%204%20Monaten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ime breastfeeding counselling'!$B$1</c:f>
              <c:strCache>
                <c:ptCount val="1"/>
                <c:pt idx="0">
                  <c:v>Total [n=214]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Time breastfeeding counselling'!$A$2:$A$13</c:f>
              <c:strCache>
                <c:ptCount val="12"/>
                <c:pt idx="0">
                  <c:v>Start of pregnancy</c:v>
                </c:pt>
                <c:pt idx="1">
                  <c:v>Registration appointment in clinic</c:v>
                </c:pt>
                <c:pt idx="2">
                  <c:v>Birth preparation course</c:v>
                </c:pt>
                <c:pt idx="3">
                  <c:v>Admission to the clinic</c:v>
                </c:pt>
                <c:pt idx="4">
                  <c:v>Directly after birth</c:v>
                </c:pt>
                <c:pt idx="5">
                  <c:v>On the day of birth</c:v>
                </c:pt>
                <c:pt idx="6">
                  <c:v>U2</c:v>
                </c:pt>
                <c:pt idx="7">
                  <c:v>First days at home</c:v>
                </c:pt>
                <c:pt idx="8">
                  <c:v>U3</c:v>
                </c:pt>
                <c:pt idx="9">
                  <c:v>In the second month postpartum</c:v>
                </c:pt>
                <c:pt idx="10">
                  <c:v>U4</c:v>
                </c:pt>
                <c:pt idx="11">
                  <c:v>U5</c:v>
                </c:pt>
              </c:strCache>
            </c:strRef>
          </c:cat>
          <c:val>
            <c:numRef>
              <c:f>'Time breastfeeding counselling'!$B$2:$B$13</c:f>
              <c:numCache>
                <c:formatCode>0.0%</c:formatCode>
                <c:ptCount val="12"/>
                <c:pt idx="0">
                  <c:v>9.8000000000000004E-2</c:v>
                </c:pt>
                <c:pt idx="1">
                  <c:v>0.22</c:v>
                </c:pt>
                <c:pt idx="2">
                  <c:v>0.621</c:v>
                </c:pt>
                <c:pt idx="3">
                  <c:v>7.4999999999999997E-2</c:v>
                </c:pt>
                <c:pt idx="4">
                  <c:v>0.64</c:v>
                </c:pt>
                <c:pt idx="5">
                  <c:v>0.47699999999999998</c:v>
                </c:pt>
                <c:pt idx="6">
                  <c:v>0.318</c:v>
                </c:pt>
                <c:pt idx="7">
                  <c:v>0.63600000000000001</c:v>
                </c:pt>
                <c:pt idx="8">
                  <c:v>8.8999999999999996E-2</c:v>
                </c:pt>
                <c:pt idx="9">
                  <c:v>7.0000000000000007E-2</c:v>
                </c:pt>
                <c:pt idx="10">
                  <c:v>3.3000000000000002E-2</c:v>
                </c:pt>
                <c:pt idx="11">
                  <c:v>2.8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04-8443-98E7-C7636839A4B3}"/>
            </c:ext>
          </c:extLst>
        </c:ser>
        <c:ser>
          <c:idx val="1"/>
          <c:order val="1"/>
          <c:tx>
            <c:strRef>
              <c:f>'Time breastfeeding counselling'!$C$1</c:f>
              <c:strCache>
                <c:ptCount val="1"/>
                <c:pt idx="0">
                  <c:v>Exclusive breastfeeding &lt; 4 months [n=44]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Time breastfeeding counselling'!$A$2:$A$13</c:f>
              <c:strCache>
                <c:ptCount val="12"/>
                <c:pt idx="0">
                  <c:v>Start of pregnancy</c:v>
                </c:pt>
                <c:pt idx="1">
                  <c:v>Registration appointment in clinic</c:v>
                </c:pt>
                <c:pt idx="2">
                  <c:v>Birth preparation course</c:v>
                </c:pt>
                <c:pt idx="3">
                  <c:v>Admission to the clinic</c:v>
                </c:pt>
                <c:pt idx="4">
                  <c:v>Directly after birth</c:v>
                </c:pt>
                <c:pt idx="5">
                  <c:v>On the day of birth</c:v>
                </c:pt>
                <c:pt idx="6">
                  <c:v>U2</c:v>
                </c:pt>
                <c:pt idx="7">
                  <c:v>First days at home</c:v>
                </c:pt>
                <c:pt idx="8">
                  <c:v>U3</c:v>
                </c:pt>
                <c:pt idx="9">
                  <c:v>In the second month postpartum</c:v>
                </c:pt>
                <c:pt idx="10">
                  <c:v>U4</c:v>
                </c:pt>
                <c:pt idx="11">
                  <c:v>U5</c:v>
                </c:pt>
              </c:strCache>
            </c:strRef>
          </c:cat>
          <c:val>
            <c:numRef>
              <c:f>'Time breastfeeding counselling'!$C$2:$C$13</c:f>
              <c:numCache>
                <c:formatCode>0.0%</c:formatCode>
                <c:ptCount val="12"/>
                <c:pt idx="0">
                  <c:v>0.20499999999999999</c:v>
                </c:pt>
                <c:pt idx="1">
                  <c:v>0.318</c:v>
                </c:pt>
                <c:pt idx="2">
                  <c:v>0.52300000000000002</c:v>
                </c:pt>
                <c:pt idx="3">
                  <c:v>0.114</c:v>
                </c:pt>
                <c:pt idx="4">
                  <c:v>0.68200000000000005</c:v>
                </c:pt>
                <c:pt idx="5">
                  <c:v>0.29499999999999998</c:v>
                </c:pt>
                <c:pt idx="6">
                  <c:v>0.25</c:v>
                </c:pt>
                <c:pt idx="7">
                  <c:v>0.432</c:v>
                </c:pt>
                <c:pt idx="8">
                  <c:v>9.0999999999999998E-2</c:v>
                </c:pt>
                <c:pt idx="9">
                  <c:v>2.3E-2</c:v>
                </c:pt>
                <c:pt idx="10">
                  <c:v>2.3E-2</c:v>
                </c:pt>
                <c:pt idx="11">
                  <c:v>2.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04-8443-98E7-C7636839A4B3}"/>
            </c:ext>
          </c:extLst>
        </c:ser>
        <c:ser>
          <c:idx val="2"/>
          <c:order val="2"/>
          <c:tx>
            <c:strRef>
              <c:f>'Time breastfeeding counselling'!$D$1</c:f>
              <c:strCache>
                <c:ptCount val="1"/>
                <c:pt idx="0">
                  <c:v>Exclusive breastfeeding ≥ 4 months [n=134]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Time breastfeeding counselling'!$A$2:$A$13</c:f>
              <c:strCache>
                <c:ptCount val="12"/>
                <c:pt idx="0">
                  <c:v>Start of pregnancy</c:v>
                </c:pt>
                <c:pt idx="1">
                  <c:v>Registration appointment in clinic</c:v>
                </c:pt>
                <c:pt idx="2">
                  <c:v>Birth preparation course</c:v>
                </c:pt>
                <c:pt idx="3">
                  <c:v>Admission to the clinic</c:v>
                </c:pt>
                <c:pt idx="4">
                  <c:v>Directly after birth</c:v>
                </c:pt>
                <c:pt idx="5">
                  <c:v>On the day of birth</c:v>
                </c:pt>
                <c:pt idx="6">
                  <c:v>U2</c:v>
                </c:pt>
                <c:pt idx="7">
                  <c:v>First days at home</c:v>
                </c:pt>
                <c:pt idx="8">
                  <c:v>U3</c:v>
                </c:pt>
                <c:pt idx="9">
                  <c:v>In the second month postpartum</c:v>
                </c:pt>
                <c:pt idx="10">
                  <c:v>U4</c:v>
                </c:pt>
                <c:pt idx="11">
                  <c:v>U5</c:v>
                </c:pt>
              </c:strCache>
            </c:strRef>
          </c:cat>
          <c:val>
            <c:numRef>
              <c:f>'Time breastfeeding counselling'!$D$2:$D$13</c:f>
              <c:numCache>
                <c:formatCode>0.0%</c:formatCode>
                <c:ptCount val="12"/>
                <c:pt idx="0">
                  <c:v>6.7000000000000004E-2</c:v>
                </c:pt>
                <c:pt idx="1">
                  <c:v>0.187</c:v>
                </c:pt>
                <c:pt idx="2">
                  <c:v>0.67200000000000004</c:v>
                </c:pt>
                <c:pt idx="3">
                  <c:v>5.1999999999999998E-2</c:v>
                </c:pt>
                <c:pt idx="4">
                  <c:v>0.627</c:v>
                </c:pt>
                <c:pt idx="5">
                  <c:v>0.51500000000000001</c:v>
                </c:pt>
                <c:pt idx="6">
                  <c:v>0.313</c:v>
                </c:pt>
                <c:pt idx="7">
                  <c:v>0.70099999999999996</c:v>
                </c:pt>
                <c:pt idx="8">
                  <c:v>8.2000000000000003E-2</c:v>
                </c:pt>
                <c:pt idx="9">
                  <c:v>8.2000000000000003E-2</c:v>
                </c:pt>
                <c:pt idx="10">
                  <c:v>4.4999999999999998E-2</c:v>
                </c:pt>
                <c:pt idx="11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F04-8443-98E7-C7636839A4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322216559"/>
        <c:axId val="322602943"/>
      </c:barChart>
      <c:catAx>
        <c:axId val="322216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22602943"/>
        <c:crosses val="autoZero"/>
        <c:auto val="1"/>
        <c:lblAlgn val="ctr"/>
        <c:lblOffset val="100"/>
        <c:noMultiLvlLbl val="0"/>
      </c:catAx>
      <c:valAx>
        <c:axId val="3226029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2221655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3866628-D641-1244-90B1-F8551C5786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3CE4C60-D02A-F744-896A-ACDF699099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6B76309-83CC-D144-8A57-82326ABE5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2D7054-4335-0D42-B18D-2ED735E2A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27FEC1-919F-9E45-8F51-28C53C5C7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0628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48B640-DC70-654C-9C59-655B4927B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5157E60-BF42-F245-BBD7-0DA9EA2517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3D0E5C6-32B3-D140-9A9F-5AC5A7D2E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8E7058F-5F91-2740-802F-365468D68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7514C97-1684-1741-8EBE-2F6B11ECD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5308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72BE9F7A-8BD7-3845-BDA9-AE0452F49D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D1E01C4-A35F-D64E-B006-82F90CE28E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66E61A-5938-0545-BF8D-452E87340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7B0C708-5860-FE4B-8AF7-094DECC9B5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42ADCBF-2DA4-D84B-B28E-5FE576AFA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6246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7C310CA-D6EE-3944-A36D-D0B947BF3A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DF1495B-B1ED-564E-A861-BFCDE5E2039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BC55252-9BAD-F24A-B847-034187090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3DC283F-BF70-5248-BAB2-77C65EB5F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644F633-07C3-CF46-98A7-B2CA8910A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1942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488143B-D1F3-ED4E-8130-AAD479773F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1EC6FE4-783F-CB4A-BB38-F7BC2CC4C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F612F3B-EA00-C144-9A45-1F43EF3B5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EB02639-088B-0B48-A0DE-07591445E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3F1BB23-5D8D-C346-A9E6-FE3386DBD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3964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BD76AE-9D08-C640-8D20-374F9D75FD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97F646A-3DA1-F949-A2A6-54927B1492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92CDA15-56CE-514F-BBEB-4F25AF3052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457D08F-8161-9B4C-BC09-C7A604196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3A6FB04-04D3-564F-A799-9762129AA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56F510E-147E-7B42-A1FA-9F2E8CE64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8403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5148A2-3270-134A-AA65-2ED465BB9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DF74910-F9D9-8749-9461-EC4BC8C6A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CF776DE-4FDF-4146-9CEE-0029DD5F6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E4D323C-055D-8247-8434-7B1857E285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19D86DE3-ADAB-024D-96CE-260012DD9B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3712F7A-1515-194B-92D9-82CBAFCC8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47A2C2E6-648C-7247-8CC2-8C9E8B77C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3623BA2-057E-034D-BCA6-9FD404E31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07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6AE1B30-345B-ED40-A821-7A3155338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7790E9B-AAD8-E341-8AEF-25814CD9C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9762097A-C648-0E46-8B3E-A8161CFBE5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56BE9BB-BB51-CB40-9026-03593FC89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9297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779DAEE-35E0-7645-9D3B-DA7B39F38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F6F7AB1-9CCD-0449-AA2B-8FF0ED43C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A940BD1-669A-B649-B746-43F4381DC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526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0997C8-46A9-1940-B205-4097D1B84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9B2306-9502-3942-BC57-54E606C98F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D19B4BF-ADF8-464F-9F55-25CBD30D37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FE85BF0-37D8-8B4D-B8C8-0D6631C1A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9272AFC-7717-A84D-9F3F-F5E1B6079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CD2D816-9522-1A48-A631-515F57F972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1515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D3FCF4-337D-9145-BC84-0197674A3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FC1E611-27FB-544B-9BFD-095866475C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0BD50EF-D419-6749-B165-17B15B6FBF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407FCCD-D465-E94E-A169-0AAB1654E7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6A0692D-A9D4-2C44-B433-BFE4F130A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6FE1654-0428-C243-A1F3-D2187CAE3F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1577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8635FF9-9EFC-9141-9D50-2C178F160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71630D2-C59B-DB41-8B59-2D86931B96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EF2C3E6-6D49-C94B-9605-DDBE6C2949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4843B-540D-AE4B-955C-79F6525C678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0723C5-F672-E44B-85FE-9876AEBD72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E3670DE-C9FA-0146-B54E-1E645984B6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15045-95AA-554E-9EEC-FF9D244123D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9795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>
            <a:extLst>
              <a:ext uri="{FF2B5EF4-FFF2-40B4-BE49-F238E27FC236}">
                <a16:creationId xmlns:a16="http://schemas.microsoft.com/office/drawing/2014/main" id="{7A249BC4-C46F-F840-BA2B-260AECCDEF6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56342319"/>
              </p:ext>
            </p:extLst>
          </p:nvPr>
        </p:nvGraphicFramePr>
        <p:xfrm>
          <a:off x="838200" y="528638"/>
          <a:ext cx="10515600" cy="5800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40280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Breitbild</PresentationFormat>
  <Paragraphs>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rtlmaier, Theresa Philomena</dc:creator>
  <cp:lastModifiedBy>Ertlmaier, Theresa Philomena</cp:lastModifiedBy>
  <cp:revision>1</cp:revision>
  <dcterms:created xsi:type="dcterms:W3CDTF">2025-03-30T15:34:24Z</dcterms:created>
  <dcterms:modified xsi:type="dcterms:W3CDTF">2025-03-30T15:37:32Z</dcterms:modified>
</cp:coreProperties>
</file>